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sldIdLst>
    <p:sldId id="299" r:id="rId2"/>
    <p:sldId id="271" r:id="rId3"/>
    <p:sldId id="298" r:id="rId4"/>
    <p:sldId id="296" r:id="rId5"/>
    <p:sldId id="259" r:id="rId6"/>
    <p:sldId id="262" r:id="rId7"/>
    <p:sldId id="263" r:id="rId8"/>
    <p:sldId id="297" r:id="rId9"/>
    <p:sldId id="272" r:id="rId10"/>
    <p:sldId id="257" r:id="rId11"/>
    <p:sldId id="261" r:id="rId12"/>
    <p:sldId id="275" r:id="rId13"/>
    <p:sldId id="289" r:id="rId14"/>
    <p:sldId id="277" r:id="rId15"/>
    <p:sldId id="258" r:id="rId16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B301B821-A1FF-4177-AEE7-76D212191A09}" styleName="Style moyen 1 - Accentuatio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Style moyen 4 - Accentuatio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3C2FFA5D-87B4-456A-9821-1D502468CF0F}" styleName="Style à thème 1 - Accentuation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125E5076-3810-47DD-B79F-674D7AD40C01}" styleName="Style foncé 1 - Accentuation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D113A9D2-9D6B-4929-AA2D-F23B5EE8CBE7}" styleName="Style à thème 2 - Accentuation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39" autoAdjust="0"/>
  </p:normalViewPr>
  <p:slideViewPr>
    <p:cSldViewPr>
      <p:cViewPr varScale="1">
        <p:scale>
          <a:sx n="112" d="100"/>
          <a:sy n="112" d="100"/>
        </p:scale>
        <p:origin x="-1500" y="-7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87FB67-0176-4DB4-8F8B-66397FB0BFEF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E2EC6C-12C0-474D-81C2-2ED67DBA4D1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45344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8820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3854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5179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9623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087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4048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533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3907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1815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2118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5307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3EDE9-E11E-414A-AF2C-559CD08548A3}" type="datetimeFigureOut">
              <a:rPr lang="fr-FR" smtClean="0"/>
              <a:t>01/07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AA2DD1-A51F-4C69-88AF-AB737438868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0566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D36F882E-092A-E37A-A5E5-B2FB8BEB84FC}"/>
              </a:ext>
            </a:extLst>
          </p:cNvPr>
          <p:cNvSpPr txBox="1"/>
          <p:nvPr/>
        </p:nvSpPr>
        <p:spPr>
          <a:xfrm>
            <a:off x="1259632" y="2763882"/>
            <a:ext cx="6840760" cy="9814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b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aterial Figure 2 : 	CIRCOS generated by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KLIPse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oftware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presenting large scale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tDNA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eletions observed in each patient.</a:t>
            </a:r>
            <a:endParaRPr lang="fr-FR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8299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2" y="1125240"/>
            <a:ext cx="4464000" cy="4464000"/>
          </a:xfrm>
          <a:prstGeom prst="rect">
            <a:avLst/>
          </a:prstGeom>
        </p:spPr>
      </p:pic>
      <p:sp>
        <p:nvSpPr>
          <p:cNvPr id="17" name="ZoneTexte 16"/>
          <p:cNvSpPr txBox="1"/>
          <p:nvPr/>
        </p:nvSpPr>
        <p:spPr>
          <a:xfrm>
            <a:off x="4211960" y="116632"/>
            <a:ext cx="7200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35</a:t>
            </a: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4744"/>
            <a:ext cx="4464000" cy="446400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AEC09748-4674-7F39-E4D6-F726C686063F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AB135D4E-4EC2-E0DC-32AA-D1AC98E299D9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0298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130951" y="116632"/>
            <a:ext cx="882098" cy="404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119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4744"/>
            <a:ext cx="4464000" cy="4464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" y="1124744"/>
            <a:ext cx="4464000" cy="4464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7DB02060-CE09-C50C-58AC-49A286ACA818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FD1C6562-6CFF-CFD6-DE2E-72A9F22592C2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258733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144640" y="116632"/>
            <a:ext cx="8547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414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2" y="1124744"/>
            <a:ext cx="4464000" cy="4464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4744"/>
            <a:ext cx="4464000" cy="4464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C734925C-2B73-C810-DE97-F65A46E73797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8398794C-E0D6-0E3F-DA8D-E6024EC2C773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444737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139952" y="116632"/>
            <a:ext cx="864096" cy="4031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425</a:t>
            </a: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2" y="1124744"/>
            <a:ext cx="4464000" cy="44640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4744"/>
            <a:ext cx="4464000" cy="4464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86464CFA-89D2-23E6-E704-78EABA942DAE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5F825F2B-01C9-88D5-847D-22CBAF568D5E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872963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139952" y="116632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428</a:t>
            </a: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2" y="1124744"/>
            <a:ext cx="4464000" cy="446400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4744"/>
            <a:ext cx="4464000" cy="4464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9FE67ECD-92FA-9DFC-0A4A-10B096D66DC7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FA2C114B-D67A-EA21-55BD-4F65FE77FD47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967069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18" y="1125240"/>
            <a:ext cx="4464000" cy="4464000"/>
          </a:xfrm>
          <a:prstGeom prst="rect">
            <a:avLst/>
          </a:prstGeom>
        </p:spPr>
      </p:pic>
      <p:sp>
        <p:nvSpPr>
          <p:cNvPr id="14" name="ZoneTexte 13"/>
          <p:cNvSpPr txBox="1"/>
          <p:nvPr/>
        </p:nvSpPr>
        <p:spPr>
          <a:xfrm>
            <a:off x="4182726" y="116632"/>
            <a:ext cx="7785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43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5282" y="1124744"/>
            <a:ext cx="4464000" cy="4464000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5CE6A6B3-BF01-0B04-5698-30F16BEA6585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65B7781B-D70C-67AB-9291-C9D11F6D6B35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85276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139952" y="116632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295</a:t>
            </a: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5240"/>
            <a:ext cx="4464000" cy="4464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2" y="1125240"/>
            <a:ext cx="4464000" cy="4464000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xmlns="" id="{639C57D2-E39F-E443-BC09-0EC98983AEBE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xmlns="" id="{499551D1-497C-4FFD-6395-613E5FE585CD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65464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>
            <a:extLst>
              <a:ext uri="{FF2B5EF4-FFF2-40B4-BE49-F238E27FC236}">
                <a16:creationId xmlns:a16="http://schemas.microsoft.com/office/drawing/2014/main" xmlns="" id="{639C57D2-E39F-E443-BC09-0EC98983AEBE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xmlns="" id="{499551D1-497C-4FFD-6395-613E5FE585CD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xmlns="" id="{DA1CEC2D-7C9B-2EBC-CE1F-CAFE5769E5E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2" y="1125240"/>
            <a:ext cx="4464000" cy="4464000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xmlns="" id="{648C1D67-E4C2-5F21-EEF4-D7859961EB1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4744"/>
            <a:ext cx="4464000" cy="4464000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xmlns="" id="{88EF5C1A-59E0-6E66-909C-441FD3F72E25}"/>
              </a:ext>
            </a:extLst>
          </p:cNvPr>
          <p:cNvSpPr txBox="1"/>
          <p:nvPr/>
        </p:nvSpPr>
        <p:spPr>
          <a:xfrm>
            <a:off x="4121950" y="116632"/>
            <a:ext cx="9001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389</a:t>
            </a:r>
          </a:p>
        </p:txBody>
      </p:sp>
    </p:spTree>
    <p:extLst>
      <p:ext uri="{BB962C8B-B14F-4D97-AF65-F5344CB8AC3E}">
        <p14:creationId xmlns:p14="http://schemas.microsoft.com/office/powerpoint/2010/main" val="6392164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139952" y="116632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392</a:t>
            </a:r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2" y="1124744"/>
            <a:ext cx="4464000" cy="4464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4744"/>
            <a:ext cx="4464000" cy="446400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C9EA3D78-C7C1-1CB3-A8A9-B0C559AA0DCA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D5035B35-701F-24DC-96A4-FDF6157679C5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79431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4744"/>
            <a:ext cx="4464000" cy="4464000"/>
          </a:xfrm>
          <a:prstGeom prst="rect">
            <a:avLst/>
          </a:prstGeom>
        </p:spPr>
      </p:pic>
      <p:sp>
        <p:nvSpPr>
          <p:cNvPr id="10" name="ZoneTexte 9"/>
          <p:cNvSpPr txBox="1"/>
          <p:nvPr/>
        </p:nvSpPr>
        <p:spPr>
          <a:xfrm>
            <a:off x="4176964" y="116632"/>
            <a:ext cx="7900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50</a:t>
            </a:r>
            <a:endParaRPr lang="fr-F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2" y="1124744"/>
            <a:ext cx="4464000" cy="4464000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AF2762BF-B37C-3FAF-F9F7-B7F00876C298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4E3C4CFB-638F-CA9F-D310-59DCC849E69B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8275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139952" y="116632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143</a:t>
            </a: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2" y="1124744"/>
            <a:ext cx="4464000" cy="44640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5240"/>
            <a:ext cx="4464000" cy="446400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F2F83EB7-B1BD-FCBC-A893-9DFD59443670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0696DEFB-04AA-82B1-0665-508421DE5366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83150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121950" y="116632"/>
            <a:ext cx="9001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145</a:t>
            </a: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5240"/>
            <a:ext cx="4464000" cy="4464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92" y="1125240"/>
            <a:ext cx="4464000" cy="4464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004D34F0-B2A5-839F-8B42-8A8CE5AEDFC5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BA2A2803-6B9B-03E1-6E38-6EC8C615F67D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32544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" y="1125240"/>
            <a:ext cx="4464000" cy="44640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4744"/>
            <a:ext cx="4464000" cy="4464000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4113815" y="116632"/>
            <a:ext cx="9163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167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72D7D81A-4D67-0566-0274-090BF2F5FDC2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400D49CD-5F3D-F2DC-EB9A-0C434AC87A3C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85291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" y="1124744"/>
            <a:ext cx="4464000" cy="4464000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4139952" y="116632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_331</a:t>
            </a:r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124744"/>
            <a:ext cx="4464000" cy="44640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CD5D1DFE-F53A-22B5-2A50-715997B74ACA}"/>
              </a:ext>
            </a:extLst>
          </p:cNvPr>
          <p:cNvSpPr txBox="1"/>
          <p:nvPr/>
        </p:nvSpPr>
        <p:spPr>
          <a:xfrm>
            <a:off x="1337162" y="5968759"/>
            <a:ext cx="1796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fr-F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dney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D9D91822-D70C-8348-5D05-1207E2CC2798}"/>
              </a:ext>
            </a:extLst>
          </p:cNvPr>
          <p:cNvSpPr txBox="1"/>
          <p:nvPr/>
        </p:nvSpPr>
        <p:spPr>
          <a:xfrm>
            <a:off x="6393310" y="5968759"/>
            <a:ext cx="9383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endParaRPr lang="fr-F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33013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21</TotalTime>
  <Words>61</Words>
  <Application>Microsoft Office PowerPoint</Application>
  <PresentationFormat>Affichage à l'écran (4:3)</PresentationFormat>
  <Paragraphs>43</Paragraphs>
  <Slides>15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5</vt:i4>
      </vt:variant>
    </vt:vector>
  </HeadingPairs>
  <TitlesOfParts>
    <vt:vector size="16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Centre Hospitalier Universitaire d'Ange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IRCOS MITOREIN</dc:title>
  <dc:creator>BELLAL SARAH</dc:creator>
  <cp:lastModifiedBy>BELLAL SARAH</cp:lastModifiedBy>
  <cp:revision>169</cp:revision>
  <dcterms:created xsi:type="dcterms:W3CDTF">2019-02-25T09:56:57Z</dcterms:created>
  <dcterms:modified xsi:type="dcterms:W3CDTF">2025-07-01T17:31:11Z</dcterms:modified>
</cp:coreProperties>
</file>